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68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1B52D-A858-49DD-8B76-5102401FF3CF}" type="datetimeFigureOut">
              <a:rPr lang="en-AU" smtClean="0"/>
              <a:pPr/>
              <a:t>25/02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23482-3F2F-4C85-961B-CAC9CC8F8443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Rectangle 1"/>
          <p:cNvSpPr>
            <a:spLocks noChangeArrowheads="1"/>
          </p:cNvSpPr>
          <p:nvPr/>
        </p:nvSpPr>
        <p:spPr bwMode="auto">
          <a:xfrm>
            <a:off x="287338" y="979488"/>
            <a:ext cx="8388350" cy="3908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eaLnBrk="0" hangingPunct="0"/>
            <a:r>
              <a:rPr lang="en-AU" sz="800" b="1">
                <a:latin typeface="Courier New" pitchFamily="49" charset="0"/>
                <a:ea typeface="Calibri" pitchFamily="34" charset="0"/>
                <a:cs typeface="Courier New" pitchFamily="49" charset="0"/>
              </a:rPr>
              <a:t>A      </a:t>
            </a:r>
            <a:endParaRPr lang="en-AU" sz="800"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primer lucqRT5’c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5’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T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CCGA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G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C3’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GGACGAAGTACCGAAAGGTCTTACCGGAAAACTCGACGCAAGAAAAATCAGAGAGATCCTCATAAAGGCCAAGAAGGGCGGAAAGTCCAAATTGTAA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CCTGCTTCATGGCTTTCCAGAATGGCCTTTTGAGCTGCGTTCTTTTTAGTCTCTCTAGGAGTATTTCCGGTTCTTCCCGCCTTTCAGGTTTAACATT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3’CC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CCTTTCAG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TT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TA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AT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5’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  primer lucqRT3’c</a:t>
            </a:r>
          </a:p>
          <a:p>
            <a:pPr eaLnBrk="0" hangingPunct="0"/>
            <a:r>
              <a:rPr lang="en-AU" sz="800" b="1">
                <a:latin typeface="Courier New" pitchFamily="49" charset="0"/>
                <a:ea typeface="Calibri" pitchFamily="34" charset="0"/>
                <a:cs typeface="Courier New" pitchFamily="49" charset="0"/>
              </a:rPr>
              <a:t>B</a:t>
            </a:r>
            <a:endParaRPr lang="en-AU" sz="800"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primer LUC*qRT5’c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5’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T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CCGA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GG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3’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TGATGAGGTTCCGAAGGGCCTGACGGGGAAACTCGACGCCCGCAAGATCCGGGAGATCCTGATCAAGGCGAAGAAGGGTGGAAAGTCGAAGCTTTAG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ACTACTCCAAGGCTTCCCGGACTGCCCCTTTGAGCTGCGGGCGTTCTAGGCCCTCTAGGACTAGTTCCGCTTCTTCCCACCTTTCAGCTTCGAAATC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3’CCC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CCTTTCAG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TT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CG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AT</a:t>
            </a:r>
            <a:r>
              <a:rPr lang="en-AU" sz="800" u="sng"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5’</a:t>
            </a:r>
          </a:p>
          <a:p>
            <a:pPr eaLnBrk="0" hangingPunct="0"/>
            <a:r>
              <a:rPr lang="en-AU" sz="800"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 primer luc*qRT3’c</a:t>
            </a:r>
          </a:p>
          <a:p>
            <a:pPr eaLnBrk="0" hangingPunct="0"/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 b="1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     </a:t>
            </a:r>
            <a:endParaRPr lang="en-AU" sz="800"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primer RenlucqRT5’b 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5’G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T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T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G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AGAAG3’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GCTATTGTTGAAGGTGCCAAGAAGTTTCCTAATACTGAATTTGTCAAAGTAAAAGGTCTTCATTTTTCGCAAGAAGATGCACCTGATGAAATGGGAAAATATATCAAATCGTTCGTTGAGCGAGTTCTCAA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CGATAACAACTTCCACGGTTCTTCAAAGGATTATGACTTAAACAGTTTCATTTTCCAGAAGTAAAAAGCGTTCTTCTACGTGGACTACTTTACCCTTTTATATAGTTTAGCAAGCAACTCGCTCAAGAGTT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                              3’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C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AGC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T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T5’ 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                                primer RenlucqRT3’b   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 b="1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D                                                                   </a:t>
            </a:r>
            <a:endParaRPr lang="en-AU" sz="800"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primer Renluc*qRT5’b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5’G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T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T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G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AGAAG3’ 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GCAATAGTGGAGGGAGCTAAGAAGTTCCCTAACACTGAGTTTGTGAAGGTGAAGGGCCTCCACTTCTCTCAGGAGGATGCTCCTGATGAGATGGGGAAGTACATCAAGAGCTTCGTAGAGAGGGTCCTTAA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CGTTATCACCTCCCTCGATTCTTCAAGGGATTGTGACTCAAACACTTCCACTTCCCGGAGGTGAAGAGAGTCCTCCTACGAGGACTACACTACCCCTTCATGTAGTTCTCGAAGCATCTCTCCCAGGAATT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                            3’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TCG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AGC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T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C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GA</a:t>
            </a:r>
            <a:r>
              <a:rPr lang="en-AU" sz="800" u="sng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A</a:t>
            </a:r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TT5’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  <a:p>
            <a:pPr eaLnBrk="0" hangingPunct="0"/>
            <a:r>
              <a:rPr lang="en-AU" sz="800">
                <a:solidFill>
                  <a:srgbClr val="000000"/>
                </a:solidFill>
                <a:latin typeface="Courier New" pitchFamily="49" charset="0"/>
                <a:ea typeface="Calibri" pitchFamily="34" charset="0"/>
                <a:cs typeface="Courier New" pitchFamily="49" charset="0"/>
              </a:rPr>
              <a:t>                                                                                                              primer Renluc*qRT3’b</a:t>
            </a:r>
            <a:endParaRPr lang="en-AU" sz="800">
              <a:latin typeface="Courier New" pitchFamily="49" charset="0"/>
              <a:ea typeface="Calibri" pitchFamily="34" charset="0"/>
              <a:cs typeface="Courier New" pitchFamily="49" charset="0"/>
            </a:endParaRPr>
          </a:p>
        </p:txBody>
      </p:sp>
      <p:sp>
        <p:nvSpPr>
          <p:cNvPr id="11267" name="TextBox 2"/>
          <p:cNvSpPr txBox="1">
            <a:spLocks noChangeArrowheads="1"/>
          </p:cNvSpPr>
          <p:nvPr/>
        </p:nvSpPr>
        <p:spPr bwMode="auto">
          <a:xfrm>
            <a:off x="539750" y="5373688"/>
            <a:ext cx="146065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hangingPunct="0"/>
            <a:r>
              <a:rPr lang="en-AU" sz="1000" dirty="0">
                <a:ea typeface="Calibri" pitchFamily="34" charset="0"/>
                <a:cs typeface="Times New Roman" pitchFamily="18" charset="0"/>
              </a:rPr>
              <a:t>Supplementary Figure </a:t>
            </a:r>
            <a:r>
              <a:rPr lang="en-AU" sz="1000" dirty="0" smtClean="0">
                <a:ea typeface="Calibri" pitchFamily="34" charset="0"/>
                <a:cs typeface="Times New Roman" pitchFamily="18" charset="0"/>
              </a:rPr>
              <a:t>4.</a:t>
            </a:r>
            <a:endParaRPr lang="en-AU" sz="1000" dirty="0">
              <a:ea typeface="Calibri" pitchFamily="34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3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Faculty of Scienc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ch moyle</dc:creator>
  <cp:lastModifiedBy>rich moyle</cp:lastModifiedBy>
  <cp:revision>2</cp:revision>
  <dcterms:created xsi:type="dcterms:W3CDTF">2014-01-14T23:49:13Z</dcterms:created>
  <dcterms:modified xsi:type="dcterms:W3CDTF">2014-02-25T01:34:33Z</dcterms:modified>
</cp:coreProperties>
</file>